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3" r:id="rId2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1348" autoAdjust="0"/>
    <p:restoredTop sz="94674"/>
  </p:normalViewPr>
  <p:slideViewPr>
    <p:cSldViewPr>
      <p:cViewPr>
        <p:scale>
          <a:sx n="220" d="100"/>
          <a:sy n="220" d="100"/>
        </p:scale>
        <p:origin x="-664" y="-712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Project_MT\IT_SW\CBF_CRISPER_PROJECT\IT8_IT33_project\qPCR\CBFox_081016\summary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Project_MT\IT_SW\CBF_CRISPER_PROJECT\IT8_IT33_project\qPCR\CBFox_081016\summary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Project_MT\IT_SW\CBF_CRISPER_PROJECT\IT8_IT33_project\qPCR\CBFox_081016\summary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Project_MT\IT_SW\CBF_CRISPER_PROJECT\IT8_IT33_project\qPCR\CBFox_081016\summary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Project_MT\IT_SW\CBF_CRISPER_PROJECT\IT8_IT33_project\qPCR\CBFox_081016\summary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Project_MT\IT_SW\CBF_CRISPER_PROJECT\IT8_IT33_project\qPCR\CBFox_081016\summary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layout>
        <c:manualLayout>
          <c:xMode val="edge"/>
          <c:yMode val="edge"/>
          <c:x val="0.23308162924289957"/>
          <c:y val="2.9695599065453777E-2"/>
        </c:manualLayout>
      </c:layout>
      <c:overlay val="0"/>
      <c:txPr>
        <a:bodyPr/>
        <a:lstStyle/>
        <a:p>
          <a:pPr>
            <a:defRPr i="1"/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2993849253691772"/>
          <c:y val="5.1408477525297057E-2"/>
          <c:w val="0.87006150746308231"/>
          <c:h val="0.9082307419905845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C$1</c:f>
              <c:strCache>
                <c:ptCount val="1"/>
                <c:pt idx="0">
                  <c:v>CBF1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E$2:$E$10</c:f>
                <c:numCache>
                  <c:formatCode>General</c:formatCode>
                  <c:ptCount val="9"/>
                  <c:pt idx="0">
                    <c:v>0.10560587701594616</c:v>
                  </c:pt>
                  <c:pt idx="1">
                    <c:v>9.3493526796430846</c:v>
                  </c:pt>
                  <c:pt idx="2">
                    <c:v>18.316942986990131</c:v>
                  </c:pt>
                  <c:pt idx="3">
                    <c:v>0.12837190801037221</c:v>
                  </c:pt>
                  <c:pt idx="4">
                    <c:v>0.18126969327409095</c:v>
                  </c:pt>
                  <c:pt idx="5">
                    <c:v>19.0939705095116</c:v>
                  </c:pt>
                  <c:pt idx="6">
                    <c:v>10.921668235479968</c:v>
                  </c:pt>
                  <c:pt idx="7">
                    <c:v>0.11839022481332719</c:v>
                  </c:pt>
                  <c:pt idx="8">
                    <c:v>0.17998986552473117</c:v>
                  </c:pt>
                </c:numCache>
              </c:numRef>
            </c:plus>
            <c:minus>
              <c:numRef>
                <c:f>Sheet1!$E$2:$E$10</c:f>
                <c:numCache>
                  <c:formatCode>General</c:formatCode>
                  <c:ptCount val="9"/>
                  <c:pt idx="0">
                    <c:v>0.10560587701594616</c:v>
                  </c:pt>
                  <c:pt idx="1">
                    <c:v>9.3493526796430846</c:v>
                  </c:pt>
                  <c:pt idx="2">
                    <c:v>18.316942986990131</c:v>
                  </c:pt>
                  <c:pt idx="3">
                    <c:v>0.12837190801037221</c:v>
                  </c:pt>
                  <c:pt idx="4">
                    <c:v>0.18126969327409095</c:v>
                  </c:pt>
                  <c:pt idx="5">
                    <c:v>19.0939705095116</c:v>
                  </c:pt>
                  <c:pt idx="6">
                    <c:v>10.921668235479968</c:v>
                  </c:pt>
                  <c:pt idx="7">
                    <c:v>0.11839022481332719</c:v>
                  </c:pt>
                  <c:pt idx="8">
                    <c:v>0.17998986552473117</c:v>
                  </c:pt>
                </c:numCache>
              </c:numRef>
            </c:minus>
          </c:errBars>
          <c:cat>
            <c:strRef>
              <c:f>Sheet1!$B$2:$B$10</c:f>
              <c:strCache>
                <c:ptCount val="9"/>
                <c:pt idx="0">
                  <c:v>Ws-2</c:v>
                </c:pt>
                <c:pt idx="1">
                  <c:v>IT-CBF1ox</c:v>
                </c:pt>
                <c:pt idx="2">
                  <c:v>IT-CBF1ox</c:v>
                </c:pt>
                <c:pt idx="3">
                  <c:v>IT-CBF3ox</c:v>
                </c:pt>
                <c:pt idx="4">
                  <c:v>IT-CBF3ox</c:v>
                </c:pt>
                <c:pt idx="5">
                  <c:v>IT8-CBF1ox</c:v>
                </c:pt>
                <c:pt idx="6">
                  <c:v>IT8-CBF1ox</c:v>
                </c:pt>
                <c:pt idx="7">
                  <c:v>IT8-CBF3ox</c:v>
                </c:pt>
                <c:pt idx="8">
                  <c:v>IT8-CBF3ox</c:v>
                </c:pt>
              </c:strCache>
            </c:strRef>
          </c:cat>
          <c:val>
            <c:numRef>
              <c:f>Sheet1!$C$2:$C$10</c:f>
              <c:numCache>
                <c:formatCode>General</c:formatCode>
                <c:ptCount val="9"/>
                <c:pt idx="0">
                  <c:v>1.0055608391640494</c:v>
                </c:pt>
                <c:pt idx="1">
                  <c:v>79.012767623022185</c:v>
                </c:pt>
                <c:pt idx="2">
                  <c:v>113.76280736978883</c:v>
                </c:pt>
                <c:pt idx="3">
                  <c:v>0.77369758757705753</c:v>
                </c:pt>
                <c:pt idx="4">
                  <c:v>2.4180654766630063</c:v>
                </c:pt>
                <c:pt idx="5">
                  <c:v>102.1641015667099</c:v>
                </c:pt>
                <c:pt idx="6">
                  <c:v>132.75127372153668</c:v>
                </c:pt>
                <c:pt idx="7">
                  <c:v>0.99771847142821979</c:v>
                </c:pt>
                <c:pt idx="8">
                  <c:v>1.026140808125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196-442D-81B2-FE1C8C9F740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0651392"/>
        <c:axId val="39551360"/>
      </c:barChart>
      <c:catAx>
        <c:axId val="4065139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crossAx val="39551360"/>
        <c:crosses val="autoZero"/>
        <c:auto val="1"/>
        <c:lblAlgn val="ctr"/>
        <c:lblOffset val="100"/>
        <c:noMultiLvlLbl val="0"/>
      </c:catAx>
      <c:valAx>
        <c:axId val="39551360"/>
        <c:scaling>
          <c:orientation val="minMax"/>
          <c:max val="15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crossAx val="4065139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200"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i="1"/>
            </a:pPr>
            <a:r>
              <a:rPr lang="en-US" i="1"/>
              <a:t>CBF2</a:t>
            </a:r>
          </a:p>
        </c:rich>
      </c:tx>
      <c:layout>
        <c:manualLayout>
          <c:xMode val="edge"/>
          <c:yMode val="edge"/>
          <c:x val="0.20324481254931812"/>
          <c:y val="4.1573838691635286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6.6691190116386967E-2"/>
          <c:y val="5.1408477525297057E-2"/>
          <c:w val="0.90390585646491162"/>
          <c:h val="0.9082307419905845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C$1</c:f>
              <c:strCache>
                <c:ptCount val="1"/>
                <c:pt idx="0">
                  <c:v>CBF1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E$13:$E$21</c:f>
                <c:numCache>
                  <c:formatCode>General</c:formatCode>
                  <c:ptCount val="9"/>
                  <c:pt idx="0">
                    <c:v>6.302695796261081E-3</c:v>
                  </c:pt>
                  <c:pt idx="1">
                    <c:v>7.088264285214288E-2</c:v>
                  </c:pt>
                  <c:pt idx="2">
                    <c:v>3.1271655705882612E-2</c:v>
                  </c:pt>
                  <c:pt idx="3">
                    <c:v>0.12433558906119967</c:v>
                  </c:pt>
                  <c:pt idx="4">
                    <c:v>0.30371212545875287</c:v>
                  </c:pt>
                  <c:pt idx="5">
                    <c:v>9.6430701337056501E-2</c:v>
                  </c:pt>
                  <c:pt idx="6">
                    <c:v>0.35142286642231746</c:v>
                  </c:pt>
                  <c:pt idx="7">
                    <c:v>8.8003948266651075E-2</c:v>
                  </c:pt>
                  <c:pt idx="8">
                    <c:v>6.2877800700717246E-2</c:v>
                  </c:pt>
                </c:numCache>
              </c:numRef>
            </c:plus>
            <c:minus>
              <c:numRef>
                <c:f>Sheet1!$E$13:$E$21</c:f>
                <c:numCache>
                  <c:formatCode>General</c:formatCode>
                  <c:ptCount val="9"/>
                  <c:pt idx="0">
                    <c:v>6.302695796261081E-3</c:v>
                  </c:pt>
                  <c:pt idx="1">
                    <c:v>7.088264285214288E-2</c:v>
                  </c:pt>
                  <c:pt idx="2">
                    <c:v>3.1271655705882612E-2</c:v>
                  </c:pt>
                  <c:pt idx="3">
                    <c:v>0.12433558906119967</c:v>
                  </c:pt>
                  <c:pt idx="4">
                    <c:v>0.30371212545875287</c:v>
                  </c:pt>
                  <c:pt idx="5">
                    <c:v>9.6430701337056501E-2</c:v>
                  </c:pt>
                  <c:pt idx="6">
                    <c:v>0.35142286642231746</c:v>
                  </c:pt>
                  <c:pt idx="7">
                    <c:v>8.8003948266651075E-2</c:v>
                  </c:pt>
                  <c:pt idx="8">
                    <c:v>6.2877800700717246E-2</c:v>
                  </c:pt>
                </c:numCache>
              </c:numRef>
            </c:minus>
          </c:errBars>
          <c:cat>
            <c:strRef>
              <c:f>Sheet1!$B$13:$B$21</c:f>
              <c:strCache>
                <c:ptCount val="9"/>
                <c:pt idx="0">
                  <c:v>Ws-2</c:v>
                </c:pt>
                <c:pt idx="1">
                  <c:v>IT-CBF1ox</c:v>
                </c:pt>
                <c:pt idx="2">
                  <c:v>IT-CBF1ox</c:v>
                </c:pt>
                <c:pt idx="3">
                  <c:v>IT-CBF3ox</c:v>
                </c:pt>
                <c:pt idx="4">
                  <c:v>IT-CBF3ox</c:v>
                </c:pt>
                <c:pt idx="5">
                  <c:v>IT8-CBF1ox</c:v>
                </c:pt>
                <c:pt idx="6">
                  <c:v>IT8-CBF1ox</c:v>
                </c:pt>
                <c:pt idx="7">
                  <c:v>IT8-CBF3ox</c:v>
                </c:pt>
                <c:pt idx="8">
                  <c:v>IT8-CBF3ox</c:v>
                </c:pt>
              </c:strCache>
            </c:strRef>
          </c:cat>
          <c:val>
            <c:numRef>
              <c:f>Sheet1!$C$13:$C$21</c:f>
              <c:numCache>
                <c:formatCode>General</c:formatCode>
                <c:ptCount val="9"/>
                <c:pt idx="0">
                  <c:v>1.0000198617899048</c:v>
                </c:pt>
                <c:pt idx="1">
                  <c:v>1.6721152358862554</c:v>
                </c:pt>
                <c:pt idx="2">
                  <c:v>0.55662157916775412</c:v>
                </c:pt>
                <c:pt idx="3">
                  <c:v>1.0358732571478357</c:v>
                </c:pt>
                <c:pt idx="4">
                  <c:v>1.8593586599976291</c:v>
                </c:pt>
                <c:pt idx="5">
                  <c:v>0.6546432796064322</c:v>
                </c:pt>
                <c:pt idx="6">
                  <c:v>0.834806662224435</c:v>
                </c:pt>
                <c:pt idx="7">
                  <c:v>0.58261892191908249</c:v>
                </c:pt>
                <c:pt idx="8">
                  <c:v>0.743643207311323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AE3-4980-BB4A-815EB091B65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9580800"/>
        <c:axId val="39582336"/>
      </c:barChart>
      <c:catAx>
        <c:axId val="3958080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crossAx val="39582336"/>
        <c:crosses val="autoZero"/>
        <c:auto val="1"/>
        <c:lblAlgn val="ctr"/>
        <c:lblOffset val="100"/>
        <c:noMultiLvlLbl val="0"/>
      </c:catAx>
      <c:valAx>
        <c:axId val="395823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39580800"/>
        <c:crosses val="autoZero"/>
        <c:crossBetween val="between"/>
        <c:majorUnit val="1"/>
      </c:valAx>
    </c:plotArea>
    <c:plotVisOnly val="1"/>
    <c:dispBlanksAs val="gap"/>
    <c:showDLblsOverMax val="0"/>
  </c:chart>
  <c:txPr>
    <a:bodyPr/>
    <a:lstStyle/>
    <a:p>
      <a:pPr>
        <a:defRPr sz="1200"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i="1"/>
            </a:pPr>
            <a:r>
              <a:rPr lang="en-US" i="1"/>
              <a:t>CBF3</a:t>
            </a:r>
          </a:p>
        </c:rich>
      </c:tx>
      <c:layout>
        <c:manualLayout>
          <c:xMode val="edge"/>
          <c:yMode val="edge"/>
          <c:x val="0.24800003758969033"/>
          <c:y val="4.1573838691635286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0936795779315464"/>
          <c:y val="5.1408477525297057E-2"/>
          <c:w val="0.88344468305098223"/>
          <c:h val="0.9082307419905845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C$1</c:f>
              <c:strCache>
                <c:ptCount val="1"/>
                <c:pt idx="0">
                  <c:v>CBF1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E$24:$E$32</c:f>
                <c:numCache>
                  <c:formatCode>General</c:formatCode>
                  <c:ptCount val="9"/>
                  <c:pt idx="0">
                    <c:v>4.892497272256191E-2</c:v>
                  </c:pt>
                  <c:pt idx="1">
                    <c:v>0.15287588664472707</c:v>
                  </c:pt>
                  <c:pt idx="2">
                    <c:v>9.4098988548904888E-2</c:v>
                  </c:pt>
                  <c:pt idx="3">
                    <c:v>5.9515783762039218</c:v>
                  </c:pt>
                  <c:pt idx="4">
                    <c:v>23.752817432105292</c:v>
                  </c:pt>
                  <c:pt idx="5">
                    <c:v>4.6612091853901291E-2</c:v>
                  </c:pt>
                  <c:pt idx="6">
                    <c:v>0.20480206527158576</c:v>
                  </c:pt>
                  <c:pt idx="7">
                    <c:v>39.67741022890538</c:v>
                  </c:pt>
                  <c:pt idx="8">
                    <c:v>41.436364443242425</c:v>
                  </c:pt>
                </c:numCache>
              </c:numRef>
            </c:plus>
            <c:minus>
              <c:numRef>
                <c:f>Sheet1!$E$24:$E$32</c:f>
                <c:numCache>
                  <c:formatCode>General</c:formatCode>
                  <c:ptCount val="9"/>
                  <c:pt idx="0">
                    <c:v>4.892497272256191E-2</c:v>
                  </c:pt>
                  <c:pt idx="1">
                    <c:v>0.15287588664472707</c:v>
                  </c:pt>
                  <c:pt idx="2">
                    <c:v>9.4098988548904888E-2</c:v>
                  </c:pt>
                  <c:pt idx="3">
                    <c:v>5.9515783762039218</c:v>
                  </c:pt>
                  <c:pt idx="4">
                    <c:v>23.752817432105292</c:v>
                  </c:pt>
                  <c:pt idx="5">
                    <c:v>4.6612091853901291E-2</c:v>
                  </c:pt>
                  <c:pt idx="6">
                    <c:v>0.20480206527158576</c:v>
                  </c:pt>
                  <c:pt idx="7">
                    <c:v>39.67741022890538</c:v>
                  </c:pt>
                  <c:pt idx="8">
                    <c:v>41.436364443242425</c:v>
                  </c:pt>
                </c:numCache>
              </c:numRef>
            </c:minus>
          </c:errBars>
          <c:cat>
            <c:strRef>
              <c:f>Sheet1!$B$24:$B$32</c:f>
              <c:strCache>
                <c:ptCount val="9"/>
                <c:pt idx="0">
                  <c:v>Ws-2</c:v>
                </c:pt>
                <c:pt idx="1">
                  <c:v>IT-CBF1ox</c:v>
                </c:pt>
                <c:pt idx="2">
                  <c:v>IT-CBF1ox</c:v>
                </c:pt>
                <c:pt idx="3">
                  <c:v>IT-CBF3ox</c:v>
                </c:pt>
                <c:pt idx="4">
                  <c:v>IT-CBF3ox</c:v>
                </c:pt>
                <c:pt idx="5">
                  <c:v>IT8-CBF1ox</c:v>
                </c:pt>
                <c:pt idx="6">
                  <c:v>IT8-CBF1ox</c:v>
                </c:pt>
                <c:pt idx="7">
                  <c:v>IT8-CBF3ox</c:v>
                </c:pt>
                <c:pt idx="8">
                  <c:v>IT8-CBF3ox</c:v>
                </c:pt>
              </c:strCache>
            </c:strRef>
          </c:cat>
          <c:val>
            <c:numRef>
              <c:f>Sheet1!$C$24:$C$32</c:f>
              <c:numCache>
                <c:formatCode>General</c:formatCode>
                <c:ptCount val="9"/>
                <c:pt idx="0">
                  <c:v>1.0011961111370256</c:v>
                </c:pt>
                <c:pt idx="1">
                  <c:v>0.83320502813920994</c:v>
                </c:pt>
                <c:pt idx="2">
                  <c:v>0.60203585427650597</c:v>
                </c:pt>
                <c:pt idx="3">
                  <c:v>432.77877857136269</c:v>
                </c:pt>
                <c:pt idx="4">
                  <c:v>409.46334184308063</c:v>
                </c:pt>
                <c:pt idx="5">
                  <c:v>0.71255657631137204</c:v>
                </c:pt>
                <c:pt idx="6">
                  <c:v>0.66228775309150545</c:v>
                </c:pt>
                <c:pt idx="7">
                  <c:v>228.91525749421157</c:v>
                </c:pt>
                <c:pt idx="8">
                  <c:v>395.8299588172898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DE4-44AE-BA7A-0B5FC7A8D8B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9607296"/>
        <c:axId val="39609088"/>
      </c:barChart>
      <c:catAx>
        <c:axId val="3960729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crossAx val="39609088"/>
        <c:crosses val="autoZero"/>
        <c:auto val="1"/>
        <c:lblAlgn val="ctr"/>
        <c:lblOffset val="100"/>
        <c:noMultiLvlLbl val="0"/>
      </c:catAx>
      <c:valAx>
        <c:axId val="3960908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3960729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200"/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i="1"/>
            </a:pPr>
            <a:r>
              <a:rPr lang="en-US" i="1" dirty="0"/>
              <a:t>Gols3</a:t>
            </a:r>
          </a:p>
        </c:rich>
      </c:tx>
      <c:layout>
        <c:manualLayout>
          <c:xMode val="edge"/>
          <c:yMode val="edge"/>
          <c:x val="0.24800003758969033"/>
          <c:y val="1.7817359439272266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0936795779315464"/>
          <c:y val="5.1408477525297057E-2"/>
          <c:w val="0.88344468305098223"/>
          <c:h val="0.8978549556305460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I$1</c:f>
              <c:strCache>
                <c:ptCount val="1"/>
                <c:pt idx="0">
                  <c:v>GolS3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K$2:$K$10</c:f>
                <c:numCache>
                  <c:formatCode>General</c:formatCode>
                  <c:ptCount val="9"/>
                  <c:pt idx="0">
                    <c:v>0.19923592536630222</c:v>
                  </c:pt>
                  <c:pt idx="1">
                    <c:v>26.88612449101441</c:v>
                  </c:pt>
                  <c:pt idx="2">
                    <c:v>37.55491834524036</c:v>
                  </c:pt>
                  <c:pt idx="3">
                    <c:v>11.666344788860259</c:v>
                  </c:pt>
                  <c:pt idx="4">
                    <c:v>39.119512904274515</c:v>
                  </c:pt>
                  <c:pt idx="5">
                    <c:v>7.3063384731158365E-2</c:v>
                  </c:pt>
                  <c:pt idx="6">
                    <c:v>5.2891644993947051E-2</c:v>
                  </c:pt>
                  <c:pt idx="7">
                    <c:v>1.967865368045894E-2</c:v>
                  </c:pt>
                  <c:pt idx="8">
                    <c:v>7.4218584865055878E-2</c:v>
                  </c:pt>
                </c:numCache>
              </c:numRef>
            </c:plus>
            <c:minus>
              <c:numRef>
                <c:f>Sheet1!$K$2:$K$10</c:f>
                <c:numCache>
                  <c:formatCode>General</c:formatCode>
                  <c:ptCount val="9"/>
                  <c:pt idx="0">
                    <c:v>0.19923592536630222</c:v>
                  </c:pt>
                  <c:pt idx="1">
                    <c:v>26.88612449101441</c:v>
                  </c:pt>
                  <c:pt idx="2">
                    <c:v>37.55491834524036</c:v>
                  </c:pt>
                  <c:pt idx="3">
                    <c:v>11.666344788860259</c:v>
                  </c:pt>
                  <c:pt idx="4">
                    <c:v>39.119512904274515</c:v>
                  </c:pt>
                  <c:pt idx="5">
                    <c:v>7.3063384731158365E-2</c:v>
                  </c:pt>
                  <c:pt idx="6">
                    <c:v>5.2891644993947051E-2</c:v>
                  </c:pt>
                  <c:pt idx="7">
                    <c:v>1.967865368045894E-2</c:v>
                  </c:pt>
                  <c:pt idx="8">
                    <c:v>7.4218584865055878E-2</c:v>
                  </c:pt>
                </c:numCache>
              </c:numRef>
            </c:minus>
          </c:errBars>
          <c:cat>
            <c:strRef>
              <c:f>Sheet1!$B$2:$B$10</c:f>
              <c:strCache>
                <c:ptCount val="9"/>
                <c:pt idx="0">
                  <c:v>Ws-2</c:v>
                </c:pt>
                <c:pt idx="1">
                  <c:v>IT-CBF1ox</c:v>
                </c:pt>
                <c:pt idx="2">
                  <c:v>IT-CBF1ox</c:v>
                </c:pt>
                <c:pt idx="3">
                  <c:v>IT-CBF3ox</c:v>
                </c:pt>
                <c:pt idx="4">
                  <c:v>IT-CBF3ox</c:v>
                </c:pt>
                <c:pt idx="5">
                  <c:v>IT8-CBF1ox</c:v>
                </c:pt>
                <c:pt idx="6">
                  <c:v>IT8-CBF1ox</c:v>
                </c:pt>
                <c:pt idx="7">
                  <c:v>IT8-CBF3ox</c:v>
                </c:pt>
                <c:pt idx="8">
                  <c:v>IT8-CBF3ox</c:v>
                </c:pt>
              </c:strCache>
            </c:strRef>
          </c:cat>
          <c:val>
            <c:numRef>
              <c:f>Sheet1!$I$2:$I$10</c:f>
              <c:numCache>
                <c:formatCode>General</c:formatCode>
                <c:ptCount val="9"/>
                <c:pt idx="0">
                  <c:v>1.0196543306221806</c:v>
                </c:pt>
                <c:pt idx="1">
                  <c:v>397.5211167582948</c:v>
                </c:pt>
                <c:pt idx="2">
                  <c:v>382.17879604213482</c:v>
                </c:pt>
                <c:pt idx="3">
                  <c:v>388.05819192941044</c:v>
                </c:pt>
                <c:pt idx="4">
                  <c:v>386.64053504941813</c:v>
                </c:pt>
                <c:pt idx="5">
                  <c:v>0.89356073020116489</c:v>
                </c:pt>
                <c:pt idx="6">
                  <c:v>1.1282257443702663</c:v>
                </c:pt>
                <c:pt idx="7">
                  <c:v>0.66753437168705965</c:v>
                </c:pt>
                <c:pt idx="8">
                  <c:v>0.9655659405684123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8BB-4B95-B51F-8C06A02C87E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9621760"/>
        <c:axId val="39623296"/>
      </c:barChart>
      <c:catAx>
        <c:axId val="3962176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crossAx val="39623296"/>
        <c:crosses val="autoZero"/>
        <c:auto val="1"/>
        <c:lblAlgn val="ctr"/>
        <c:lblOffset val="100"/>
        <c:noMultiLvlLbl val="0"/>
      </c:catAx>
      <c:valAx>
        <c:axId val="396232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3962176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200"/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i="1"/>
            </a:pPr>
            <a:r>
              <a:rPr lang="en-US" i="1"/>
              <a:t>COR15a</a:t>
            </a:r>
          </a:p>
        </c:rich>
      </c:tx>
      <c:layout>
        <c:manualLayout>
          <c:xMode val="edge"/>
          <c:yMode val="edge"/>
          <c:x val="0.24800003758969033"/>
          <c:y val="4.1573838691635286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3070634163153849"/>
          <c:y val="5.1408477525297057E-2"/>
          <c:w val="0.86929365836846151"/>
          <c:h val="0.9082307419905845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I$1</c:f>
              <c:strCache>
                <c:ptCount val="1"/>
                <c:pt idx="0">
                  <c:v>GolS3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K$13:$K$21</c:f>
                <c:numCache>
                  <c:formatCode>General</c:formatCode>
                  <c:ptCount val="9"/>
                  <c:pt idx="0">
                    <c:v>3.5382425014986341E-2</c:v>
                  </c:pt>
                  <c:pt idx="1">
                    <c:v>29.210469972315479</c:v>
                  </c:pt>
                  <c:pt idx="2">
                    <c:v>29.850061968717387</c:v>
                  </c:pt>
                  <c:pt idx="3">
                    <c:v>65.681414214889003</c:v>
                  </c:pt>
                  <c:pt idx="4">
                    <c:v>110.15719535152432</c:v>
                  </c:pt>
                  <c:pt idx="5">
                    <c:v>0.11663000091002135</c:v>
                  </c:pt>
                  <c:pt idx="6">
                    <c:v>0.16465251496795241</c:v>
                  </c:pt>
                  <c:pt idx="7">
                    <c:v>5.4732931676463467E-2</c:v>
                  </c:pt>
                  <c:pt idx="8">
                    <c:v>3.5098152133414995E-2</c:v>
                  </c:pt>
                </c:numCache>
              </c:numRef>
            </c:plus>
            <c:minus>
              <c:numRef>
                <c:f>Sheet1!$K$13:$K$21</c:f>
                <c:numCache>
                  <c:formatCode>General</c:formatCode>
                  <c:ptCount val="9"/>
                  <c:pt idx="0">
                    <c:v>3.5382425014986341E-2</c:v>
                  </c:pt>
                  <c:pt idx="1">
                    <c:v>29.210469972315479</c:v>
                  </c:pt>
                  <c:pt idx="2">
                    <c:v>29.850061968717387</c:v>
                  </c:pt>
                  <c:pt idx="3">
                    <c:v>65.681414214889003</c:v>
                  </c:pt>
                  <c:pt idx="4">
                    <c:v>110.15719535152432</c:v>
                  </c:pt>
                  <c:pt idx="5">
                    <c:v>0.11663000091002135</c:v>
                  </c:pt>
                  <c:pt idx="6">
                    <c:v>0.16465251496795241</c:v>
                  </c:pt>
                  <c:pt idx="7">
                    <c:v>5.4732931676463467E-2</c:v>
                  </c:pt>
                  <c:pt idx="8">
                    <c:v>3.5098152133414995E-2</c:v>
                  </c:pt>
                </c:numCache>
              </c:numRef>
            </c:minus>
          </c:errBars>
          <c:cat>
            <c:strRef>
              <c:f>Sheet1!$B$13:$B$21</c:f>
              <c:strCache>
                <c:ptCount val="9"/>
                <c:pt idx="0">
                  <c:v>Ws-2</c:v>
                </c:pt>
                <c:pt idx="1">
                  <c:v>IT-CBF1ox</c:v>
                </c:pt>
                <c:pt idx="2">
                  <c:v>IT-CBF1ox</c:v>
                </c:pt>
                <c:pt idx="3">
                  <c:v>IT-CBF3ox</c:v>
                </c:pt>
                <c:pt idx="4">
                  <c:v>IT-CBF3ox</c:v>
                </c:pt>
                <c:pt idx="5">
                  <c:v>IT8-CBF1ox</c:v>
                </c:pt>
                <c:pt idx="6">
                  <c:v>IT8-CBF1ox</c:v>
                </c:pt>
                <c:pt idx="7">
                  <c:v>IT8-CBF3ox</c:v>
                </c:pt>
                <c:pt idx="8">
                  <c:v>IT8-CBF3ox</c:v>
                </c:pt>
              </c:strCache>
            </c:strRef>
          </c:cat>
          <c:val>
            <c:numRef>
              <c:f>Sheet1!$I$13:$I$21</c:f>
              <c:numCache>
                <c:formatCode>General</c:formatCode>
                <c:ptCount val="9"/>
                <c:pt idx="0">
                  <c:v>1.0006257622107984</c:v>
                </c:pt>
                <c:pt idx="1">
                  <c:v>1120.9315341993738</c:v>
                </c:pt>
                <c:pt idx="2">
                  <c:v>1002.2878301785662</c:v>
                </c:pt>
                <c:pt idx="3">
                  <c:v>1254.9558260643423</c:v>
                </c:pt>
                <c:pt idx="4">
                  <c:v>1215.1495489066128</c:v>
                </c:pt>
                <c:pt idx="5">
                  <c:v>0.5905089355208536</c:v>
                </c:pt>
                <c:pt idx="6">
                  <c:v>0.67036268402042964</c:v>
                </c:pt>
                <c:pt idx="7">
                  <c:v>0.31757069397313886</c:v>
                </c:pt>
                <c:pt idx="8">
                  <c:v>0.569126981529424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503-42BA-BDFB-424B034FDDA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9648256"/>
        <c:axId val="40182528"/>
      </c:barChart>
      <c:catAx>
        <c:axId val="3964825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crossAx val="40182528"/>
        <c:crosses val="autoZero"/>
        <c:auto val="1"/>
        <c:lblAlgn val="ctr"/>
        <c:lblOffset val="100"/>
        <c:noMultiLvlLbl val="0"/>
      </c:catAx>
      <c:valAx>
        <c:axId val="401825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39648256"/>
        <c:crosses val="autoZero"/>
        <c:crossBetween val="between"/>
        <c:majorUnit val="500"/>
      </c:valAx>
    </c:plotArea>
    <c:plotVisOnly val="1"/>
    <c:dispBlanksAs val="gap"/>
    <c:showDLblsOverMax val="0"/>
  </c:chart>
  <c:txPr>
    <a:bodyPr/>
    <a:lstStyle/>
    <a:p>
      <a:pPr>
        <a:defRPr sz="1200"/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i="1"/>
            </a:pPr>
            <a:r>
              <a:rPr lang="en-US" i="1"/>
              <a:t>COR47</a:t>
            </a:r>
          </a:p>
        </c:rich>
      </c:tx>
      <c:layout>
        <c:manualLayout>
          <c:xMode val="edge"/>
          <c:yMode val="edge"/>
          <c:x val="0.24800003758969033"/>
          <c:y val="1.7817359439272266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8.8029573954770804E-2"/>
          <c:y val="5.1408477525297057E-2"/>
          <c:w val="0.91197042604522915"/>
          <c:h val="0.9082307419905845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I$1</c:f>
              <c:strCache>
                <c:ptCount val="1"/>
                <c:pt idx="0">
                  <c:v>GolS3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K$24:$K$32</c:f>
                <c:numCache>
                  <c:formatCode>General</c:formatCode>
                  <c:ptCount val="9"/>
                  <c:pt idx="0">
                    <c:v>0.20254342741788678</c:v>
                  </c:pt>
                  <c:pt idx="1">
                    <c:v>3.0548759208767167</c:v>
                  </c:pt>
                  <c:pt idx="2">
                    <c:v>1.1566534307841738</c:v>
                  </c:pt>
                  <c:pt idx="3">
                    <c:v>1.6856414656294816</c:v>
                  </c:pt>
                  <c:pt idx="4">
                    <c:v>1.8916048029150858</c:v>
                  </c:pt>
                  <c:pt idx="5">
                    <c:v>0.15744400462736563</c:v>
                  </c:pt>
                  <c:pt idx="6">
                    <c:v>0.31964105972666024</c:v>
                  </c:pt>
                  <c:pt idx="7">
                    <c:v>0.10713529787597398</c:v>
                  </c:pt>
                  <c:pt idx="8">
                    <c:v>0.20805222025473807</c:v>
                  </c:pt>
                </c:numCache>
              </c:numRef>
            </c:plus>
            <c:minus>
              <c:numRef>
                <c:f>Sheet1!$K$24:$K$32</c:f>
                <c:numCache>
                  <c:formatCode>General</c:formatCode>
                  <c:ptCount val="9"/>
                  <c:pt idx="0">
                    <c:v>0.20254342741788678</c:v>
                  </c:pt>
                  <c:pt idx="1">
                    <c:v>3.0548759208767167</c:v>
                  </c:pt>
                  <c:pt idx="2">
                    <c:v>1.1566534307841738</c:v>
                  </c:pt>
                  <c:pt idx="3">
                    <c:v>1.6856414656294816</c:v>
                  </c:pt>
                  <c:pt idx="4">
                    <c:v>1.8916048029150858</c:v>
                  </c:pt>
                  <c:pt idx="5">
                    <c:v>0.15744400462736563</c:v>
                  </c:pt>
                  <c:pt idx="6">
                    <c:v>0.31964105972666024</c:v>
                  </c:pt>
                  <c:pt idx="7">
                    <c:v>0.10713529787597398</c:v>
                  </c:pt>
                  <c:pt idx="8">
                    <c:v>0.20805222025473807</c:v>
                  </c:pt>
                </c:numCache>
              </c:numRef>
            </c:minus>
          </c:errBars>
          <c:cat>
            <c:strRef>
              <c:f>Sheet1!$B$24:$B$32</c:f>
              <c:strCache>
                <c:ptCount val="9"/>
                <c:pt idx="0">
                  <c:v>Ws-2</c:v>
                </c:pt>
                <c:pt idx="1">
                  <c:v>IT-CBF1ox</c:v>
                </c:pt>
                <c:pt idx="2">
                  <c:v>IT-CBF1ox</c:v>
                </c:pt>
                <c:pt idx="3">
                  <c:v>IT-CBF3ox</c:v>
                </c:pt>
                <c:pt idx="4">
                  <c:v>IT-CBF3ox</c:v>
                </c:pt>
                <c:pt idx="5">
                  <c:v>IT8-CBF1ox</c:v>
                </c:pt>
                <c:pt idx="6">
                  <c:v>IT8-CBF1ox</c:v>
                </c:pt>
                <c:pt idx="7">
                  <c:v>IT8-CBF3ox</c:v>
                </c:pt>
                <c:pt idx="8">
                  <c:v>IT8-CBF3ox</c:v>
                </c:pt>
              </c:strCache>
            </c:strRef>
          </c:cat>
          <c:val>
            <c:numRef>
              <c:f>Sheet1!$I$24:$I$32</c:f>
              <c:numCache>
                <c:formatCode>General</c:formatCode>
                <c:ptCount val="9"/>
                <c:pt idx="0">
                  <c:v>1.0203057580893016</c:v>
                </c:pt>
                <c:pt idx="1">
                  <c:v>47.089414095406134</c:v>
                </c:pt>
                <c:pt idx="2">
                  <c:v>33.906180536064277</c:v>
                </c:pt>
                <c:pt idx="3">
                  <c:v>46.530655869486452</c:v>
                </c:pt>
                <c:pt idx="4">
                  <c:v>49.268490359042715</c:v>
                </c:pt>
                <c:pt idx="5">
                  <c:v>1.1112899990105911</c:v>
                </c:pt>
                <c:pt idx="6">
                  <c:v>2.221386067945307</c:v>
                </c:pt>
                <c:pt idx="7">
                  <c:v>1.3218635952966444</c:v>
                </c:pt>
                <c:pt idx="8">
                  <c:v>1.856060215891105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1F0-48A2-A4D8-3096316AB1D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0211584"/>
        <c:axId val="40213120"/>
      </c:barChart>
      <c:catAx>
        <c:axId val="4021158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crossAx val="40213120"/>
        <c:crosses val="autoZero"/>
        <c:auto val="1"/>
        <c:lblAlgn val="ctr"/>
        <c:lblOffset val="100"/>
        <c:noMultiLvlLbl val="0"/>
      </c:catAx>
      <c:valAx>
        <c:axId val="4021312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4021158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200"/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030E226-D7DD-4781-A018-168D61DA236F}" type="datetimeFigureOut">
              <a:rPr lang="en-US" smtClean="0"/>
              <a:t>11/9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7100" y="696913"/>
            <a:ext cx="2616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16425"/>
            <a:ext cx="5607050" cy="418306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C8B2109-89AE-4D74-A9A0-6138A32777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00219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9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9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9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1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38295" y="7866727"/>
            <a:ext cx="6391105" cy="12772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/>
              <a:t>S2 Fig. The </a:t>
            </a:r>
            <a:r>
              <a:rPr lang="en-US" sz="1100" b="1" i="1" dirty="0"/>
              <a:t>cbf1</a:t>
            </a:r>
            <a:r>
              <a:rPr lang="en-US" sz="1100" b="1" dirty="0"/>
              <a:t> and </a:t>
            </a:r>
            <a:r>
              <a:rPr lang="en-US" sz="1100" b="1" i="1" dirty="0"/>
              <a:t>cbf3</a:t>
            </a:r>
            <a:r>
              <a:rPr lang="en-US" sz="1100" b="1" dirty="0"/>
              <a:t> alleles from it:</a:t>
            </a:r>
            <a:r>
              <a:rPr lang="en-US" sz="1100" b="1" i="1" dirty="0"/>
              <a:t>cbf123</a:t>
            </a:r>
            <a:r>
              <a:rPr lang="en-US" sz="1100" b="1" dirty="0"/>
              <a:t> plants encode non-functional proteins.  </a:t>
            </a:r>
            <a:r>
              <a:rPr lang="en-US" sz="1100" dirty="0"/>
              <a:t>The </a:t>
            </a:r>
            <a:r>
              <a:rPr lang="en-US" sz="1100" i="1" dirty="0"/>
              <a:t>cbf1</a:t>
            </a:r>
            <a:r>
              <a:rPr lang="en-US" sz="1100" dirty="0"/>
              <a:t> and </a:t>
            </a:r>
            <a:r>
              <a:rPr lang="en-US" sz="1100" i="1" dirty="0"/>
              <a:t>cbf3</a:t>
            </a:r>
            <a:r>
              <a:rPr lang="en-US" sz="1100" dirty="0"/>
              <a:t> alleles and corresponding </a:t>
            </a:r>
            <a:r>
              <a:rPr lang="en-US" sz="1100" i="1" dirty="0"/>
              <a:t>CBF1</a:t>
            </a:r>
            <a:r>
              <a:rPr lang="en-US" sz="1100" dirty="0"/>
              <a:t> and </a:t>
            </a:r>
            <a:r>
              <a:rPr lang="en-US" sz="1100" i="1" dirty="0"/>
              <a:t>CBF3</a:t>
            </a:r>
            <a:r>
              <a:rPr lang="en-US" sz="1100" dirty="0"/>
              <a:t> WT coding sequences from the IT ecotype were overexpressed in Ws-2 plants to determine whether they could induce expression of CBF regulon genes.  (A) Photographs show that overexpression of the </a:t>
            </a:r>
            <a:r>
              <a:rPr lang="en-US" sz="1100" i="1" dirty="0"/>
              <a:t>cbf1</a:t>
            </a:r>
            <a:r>
              <a:rPr lang="en-US" sz="1100" dirty="0"/>
              <a:t> and </a:t>
            </a:r>
            <a:r>
              <a:rPr lang="en-US" sz="1100" i="1" dirty="0"/>
              <a:t>cbf3</a:t>
            </a:r>
            <a:r>
              <a:rPr lang="en-US" sz="1100" dirty="0"/>
              <a:t> alleles did not retard plant growth consistent with the proteins being non-functional.  (B) Overexpression of </a:t>
            </a:r>
            <a:r>
              <a:rPr lang="en-US" sz="1100" i="1" dirty="0"/>
              <a:t>cbf1</a:t>
            </a:r>
            <a:r>
              <a:rPr lang="en-US" sz="1100" dirty="0"/>
              <a:t> and </a:t>
            </a:r>
            <a:r>
              <a:rPr lang="en-US" sz="1100" i="1" dirty="0"/>
              <a:t>cbf3</a:t>
            </a:r>
            <a:r>
              <a:rPr lang="en-US" sz="1100" dirty="0"/>
              <a:t> did not induce expression of the CBF regulon genes</a:t>
            </a:r>
            <a:r>
              <a:rPr lang="en-US" sz="1100" i="1" dirty="0"/>
              <a:t> Gols3</a:t>
            </a:r>
            <a:r>
              <a:rPr lang="en-US" sz="1100" dirty="0"/>
              <a:t>, </a:t>
            </a:r>
            <a:r>
              <a:rPr lang="en-US" sz="1100" i="1" dirty="0"/>
              <a:t>COR15a</a:t>
            </a:r>
            <a:r>
              <a:rPr lang="en-US" sz="1100" dirty="0"/>
              <a:t> or </a:t>
            </a:r>
            <a:r>
              <a:rPr lang="en-US" sz="1100" i="1" dirty="0"/>
              <a:t>COR47</a:t>
            </a:r>
            <a:r>
              <a:rPr lang="en-US" sz="1100" dirty="0"/>
              <a:t>. Names in parentheses on the x-axis indicate the lines from which the overexpressed alleles are cloned.  Error bars indicate SE for three biological replicates..  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1036610" y="374170"/>
            <a:ext cx="4654937" cy="1785938"/>
            <a:chOff x="1600200" y="1871662"/>
            <a:chExt cx="4654937" cy="1785938"/>
          </a:xfrm>
        </p:grpSpPr>
        <p:grpSp>
          <p:nvGrpSpPr>
            <p:cNvPr id="4" name="Group 3"/>
            <p:cNvGrpSpPr/>
            <p:nvPr/>
          </p:nvGrpSpPr>
          <p:grpSpPr>
            <a:xfrm>
              <a:off x="1600200" y="1928815"/>
              <a:ext cx="4654937" cy="1728785"/>
              <a:chOff x="1600200" y="1928815"/>
              <a:chExt cx="4654937" cy="1728785"/>
            </a:xfrm>
          </p:grpSpPr>
          <p:sp>
            <p:nvSpPr>
              <p:cNvPr id="15" name="Rectangle 14"/>
              <p:cNvSpPr/>
              <p:nvPr/>
            </p:nvSpPr>
            <p:spPr>
              <a:xfrm>
                <a:off x="1600200" y="1928815"/>
                <a:ext cx="4654296" cy="207818"/>
              </a:xfrm>
              <a:prstGeom prst="rect">
                <a:avLst/>
              </a:prstGeom>
              <a:ln>
                <a:noFill/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pic>
            <p:nvPicPr>
              <p:cNvPr id="16" name="Picture 2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600201" y="1981200"/>
                <a:ext cx="4654936" cy="16764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cxnSp>
          <p:nvCxnSpPr>
            <p:cNvPr id="5" name="Straight Connector 4"/>
            <p:cNvCxnSpPr/>
            <p:nvPr/>
          </p:nvCxnSpPr>
          <p:spPr>
            <a:xfrm>
              <a:off x="2034183" y="2114548"/>
              <a:ext cx="986441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Straight Connector 5"/>
            <p:cNvCxnSpPr/>
            <p:nvPr/>
          </p:nvCxnSpPr>
          <p:spPr>
            <a:xfrm>
              <a:off x="3843291" y="2105023"/>
              <a:ext cx="986441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Straight Connector 6"/>
            <p:cNvCxnSpPr/>
            <p:nvPr/>
          </p:nvCxnSpPr>
          <p:spPr>
            <a:xfrm>
              <a:off x="3815957" y="3195637"/>
              <a:ext cx="986442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Straight Connector 7"/>
            <p:cNvCxnSpPr/>
            <p:nvPr/>
          </p:nvCxnSpPr>
          <p:spPr>
            <a:xfrm>
              <a:off x="1954539" y="3200400"/>
              <a:ext cx="986441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8"/>
            <p:cNvSpPr txBox="1"/>
            <p:nvPr/>
          </p:nvSpPr>
          <p:spPr>
            <a:xfrm>
              <a:off x="1855311" y="1871662"/>
              <a:ext cx="127958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i="1" dirty="0">
                  <a:solidFill>
                    <a:schemeClr val="bg1"/>
                  </a:solidFill>
                </a:rPr>
                <a:t>cbf1</a:t>
              </a:r>
              <a:r>
                <a:rPr lang="en-US" sz="1200" dirty="0">
                  <a:solidFill>
                    <a:schemeClr val="bg1"/>
                  </a:solidFill>
                </a:rPr>
                <a:t>ox (it:</a:t>
              </a:r>
              <a:r>
                <a:rPr lang="en-US" sz="1200" i="1" dirty="0">
                  <a:solidFill>
                    <a:schemeClr val="bg1"/>
                  </a:solidFill>
                </a:rPr>
                <a:t>cbf123)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3653028" y="1875643"/>
              <a:ext cx="127958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i="1" dirty="0">
                  <a:solidFill>
                    <a:schemeClr val="bg1"/>
                  </a:solidFill>
                </a:rPr>
                <a:t>cbf3</a:t>
              </a:r>
              <a:r>
                <a:rPr lang="en-US" sz="1200" dirty="0">
                  <a:solidFill>
                    <a:schemeClr val="bg1"/>
                  </a:solidFill>
                </a:rPr>
                <a:t>ox (it:</a:t>
              </a:r>
              <a:r>
                <a:rPr lang="en-US" sz="1200" i="1" dirty="0">
                  <a:solidFill>
                    <a:schemeClr val="bg1"/>
                  </a:solidFill>
                </a:rPr>
                <a:t>cbf123)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5508478" y="1894692"/>
              <a:ext cx="50135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Ws-2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288552" y="3124200"/>
              <a:ext cx="4876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1 cm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034183" y="2971028"/>
              <a:ext cx="8869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CBF1ox (IT)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3872300" y="2971031"/>
              <a:ext cx="8869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CBF3ox (IT)</a:t>
              </a:r>
            </a:p>
          </p:txBody>
        </p:sp>
      </p:grpSp>
      <p:graphicFrame>
        <p:nvGraphicFramePr>
          <p:cNvPr id="17" name="Chart 1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94777407"/>
              </p:ext>
            </p:extLst>
          </p:nvPr>
        </p:nvGraphicFramePr>
        <p:xfrm>
          <a:off x="538779" y="2590800"/>
          <a:ext cx="2926080" cy="1371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8" name="Chart 1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4320196"/>
              </p:ext>
            </p:extLst>
          </p:nvPr>
        </p:nvGraphicFramePr>
        <p:xfrm>
          <a:off x="655320" y="4267200"/>
          <a:ext cx="2926080" cy="1371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9" name="Chart 1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01086799"/>
              </p:ext>
            </p:extLst>
          </p:nvPr>
        </p:nvGraphicFramePr>
        <p:xfrm>
          <a:off x="521847" y="5966012"/>
          <a:ext cx="2926080" cy="1371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0" name="Chart 1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60431712"/>
              </p:ext>
            </p:extLst>
          </p:nvPr>
        </p:nvGraphicFramePr>
        <p:xfrm>
          <a:off x="3592266" y="2590800"/>
          <a:ext cx="2926080" cy="1371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1" name="Chart 2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29882202"/>
              </p:ext>
            </p:extLst>
          </p:nvPr>
        </p:nvGraphicFramePr>
        <p:xfrm>
          <a:off x="3548182" y="4276165"/>
          <a:ext cx="2926080" cy="1371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22" name="Chart 2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16348637"/>
              </p:ext>
            </p:extLst>
          </p:nvPr>
        </p:nvGraphicFramePr>
        <p:xfrm>
          <a:off x="3703320" y="5943600"/>
          <a:ext cx="2926080" cy="1371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pSp>
        <p:nvGrpSpPr>
          <p:cNvPr id="50" name="Group 49"/>
          <p:cNvGrpSpPr/>
          <p:nvPr/>
        </p:nvGrpSpPr>
        <p:grpSpPr>
          <a:xfrm>
            <a:off x="1262602" y="4020671"/>
            <a:ext cx="2090198" cy="0"/>
            <a:chOff x="1208814" y="4164106"/>
            <a:chExt cx="2090198" cy="0"/>
          </a:xfrm>
        </p:grpSpPr>
        <p:cxnSp>
          <p:nvCxnSpPr>
            <p:cNvPr id="25" name="Straight Connector 24"/>
            <p:cNvCxnSpPr/>
            <p:nvPr/>
          </p:nvCxnSpPr>
          <p:spPr>
            <a:xfrm>
              <a:off x="1208814" y="4164106"/>
              <a:ext cx="40145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1" name="Straight Connector 40"/>
            <p:cNvCxnSpPr/>
            <p:nvPr/>
          </p:nvCxnSpPr>
          <p:spPr>
            <a:xfrm>
              <a:off x="1771728" y="4164106"/>
              <a:ext cx="40145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2" name="Straight Connector 41"/>
            <p:cNvCxnSpPr/>
            <p:nvPr/>
          </p:nvCxnSpPr>
          <p:spPr>
            <a:xfrm>
              <a:off x="2334642" y="4164106"/>
              <a:ext cx="40145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3" name="Straight Connector 42"/>
            <p:cNvCxnSpPr/>
            <p:nvPr/>
          </p:nvCxnSpPr>
          <p:spPr>
            <a:xfrm>
              <a:off x="2897557" y="4164106"/>
              <a:ext cx="40145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44" name="TextBox 22"/>
          <p:cNvSpPr txBox="1"/>
          <p:nvPr/>
        </p:nvSpPr>
        <p:spPr>
          <a:xfrm>
            <a:off x="807317" y="7379978"/>
            <a:ext cx="5013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/>
              <a:t>Ws-2</a:t>
            </a:r>
          </a:p>
        </p:txBody>
      </p:sp>
      <p:sp>
        <p:nvSpPr>
          <p:cNvPr id="45" name="TextBox 28"/>
          <p:cNvSpPr txBox="1"/>
          <p:nvPr/>
        </p:nvSpPr>
        <p:spPr>
          <a:xfrm>
            <a:off x="1173877" y="7404490"/>
            <a:ext cx="68018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200" dirty="0"/>
              <a:t>CBF1ox </a:t>
            </a:r>
          </a:p>
          <a:p>
            <a:pPr algn="ctr"/>
            <a:r>
              <a:rPr lang="en-US" sz="1200" dirty="0"/>
              <a:t>(IT)</a:t>
            </a:r>
          </a:p>
        </p:txBody>
      </p:sp>
      <p:sp>
        <p:nvSpPr>
          <p:cNvPr id="46" name="TextBox 23"/>
          <p:cNvSpPr txBox="1"/>
          <p:nvPr/>
        </p:nvSpPr>
        <p:spPr>
          <a:xfrm>
            <a:off x="1729848" y="7404490"/>
            <a:ext cx="64492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200" dirty="0"/>
              <a:t>CBF3ox</a:t>
            </a:r>
          </a:p>
          <a:p>
            <a:pPr algn="ctr"/>
            <a:r>
              <a:rPr lang="en-US" sz="1200" dirty="0"/>
              <a:t>(IT)</a:t>
            </a:r>
          </a:p>
        </p:txBody>
      </p:sp>
      <p:sp>
        <p:nvSpPr>
          <p:cNvPr id="47" name="TextBox 37"/>
          <p:cNvSpPr txBox="1"/>
          <p:nvPr/>
        </p:nvSpPr>
        <p:spPr>
          <a:xfrm>
            <a:off x="2835728" y="7406664"/>
            <a:ext cx="83260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200" dirty="0"/>
              <a:t>cbf3ox</a:t>
            </a:r>
          </a:p>
          <a:p>
            <a:pPr algn="ctr"/>
            <a:r>
              <a:rPr lang="en-US" sz="1200" dirty="0"/>
              <a:t>(it:</a:t>
            </a:r>
            <a:r>
              <a:rPr lang="en-US" sz="1200" i="1" dirty="0"/>
              <a:t>cbf123</a:t>
            </a:r>
            <a:r>
              <a:rPr lang="en-US" sz="1200" dirty="0"/>
              <a:t>)</a:t>
            </a:r>
          </a:p>
        </p:txBody>
      </p:sp>
      <p:sp>
        <p:nvSpPr>
          <p:cNvPr id="49" name="TextBox 27"/>
          <p:cNvSpPr txBox="1"/>
          <p:nvPr/>
        </p:nvSpPr>
        <p:spPr>
          <a:xfrm>
            <a:off x="2176509" y="7406664"/>
            <a:ext cx="83260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200" dirty="0"/>
              <a:t>cbf1ox</a:t>
            </a:r>
          </a:p>
          <a:p>
            <a:pPr algn="ctr"/>
            <a:r>
              <a:rPr lang="en-US" sz="1200" dirty="0"/>
              <a:t>(it:</a:t>
            </a:r>
            <a:r>
              <a:rPr lang="en-US" sz="1200" i="1" dirty="0"/>
              <a:t>cbf123</a:t>
            </a:r>
            <a:r>
              <a:rPr lang="en-US" sz="1200" dirty="0"/>
              <a:t>)</a:t>
            </a:r>
          </a:p>
        </p:txBody>
      </p:sp>
      <p:grpSp>
        <p:nvGrpSpPr>
          <p:cNvPr id="51" name="Group 50"/>
          <p:cNvGrpSpPr/>
          <p:nvPr/>
        </p:nvGrpSpPr>
        <p:grpSpPr>
          <a:xfrm>
            <a:off x="4401145" y="4020671"/>
            <a:ext cx="2090198" cy="0"/>
            <a:chOff x="1208814" y="4164106"/>
            <a:chExt cx="2090198" cy="0"/>
          </a:xfrm>
        </p:grpSpPr>
        <p:cxnSp>
          <p:nvCxnSpPr>
            <p:cNvPr id="52" name="Straight Connector 51"/>
            <p:cNvCxnSpPr/>
            <p:nvPr/>
          </p:nvCxnSpPr>
          <p:spPr>
            <a:xfrm>
              <a:off x="1208814" y="4164106"/>
              <a:ext cx="40145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3" name="Straight Connector 52"/>
            <p:cNvCxnSpPr/>
            <p:nvPr/>
          </p:nvCxnSpPr>
          <p:spPr>
            <a:xfrm>
              <a:off x="1771728" y="4164106"/>
              <a:ext cx="40145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4" name="Straight Connector 53"/>
            <p:cNvCxnSpPr/>
            <p:nvPr/>
          </p:nvCxnSpPr>
          <p:spPr>
            <a:xfrm>
              <a:off x="2334642" y="4164106"/>
              <a:ext cx="40145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5" name="Straight Connector 54"/>
            <p:cNvCxnSpPr/>
            <p:nvPr/>
          </p:nvCxnSpPr>
          <p:spPr>
            <a:xfrm>
              <a:off x="2897557" y="4164106"/>
              <a:ext cx="40145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6" name="Group 55"/>
          <p:cNvGrpSpPr/>
          <p:nvPr/>
        </p:nvGrpSpPr>
        <p:grpSpPr>
          <a:xfrm>
            <a:off x="4373504" y="5741894"/>
            <a:ext cx="2090198" cy="0"/>
            <a:chOff x="1208814" y="4164106"/>
            <a:chExt cx="2090198" cy="0"/>
          </a:xfrm>
        </p:grpSpPr>
        <p:cxnSp>
          <p:nvCxnSpPr>
            <p:cNvPr id="57" name="Straight Connector 56"/>
            <p:cNvCxnSpPr/>
            <p:nvPr/>
          </p:nvCxnSpPr>
          <p:spPr>
            <a:xfrm>
              <a:off x="1208814" y="4164106"/>
              <a:ext cx="40145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8" name="Straight Connector 57"/>
            <p:cNvCxnSpPr/>
            <p:nvPr/>
          </p:nvCxnSpPr>
          <p:spPr>
            <a:xfrm>
              <a:off x="1771728" y="4164106"/>
              <a:ext cx="40145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9" name="Straight Connector 58"/>
            <p:cNvCxnSpPr/>
            <p:nvPr/>
          </p:nvCxnSpPr>
          <p:spPr>
            <a:xfrm>
              <a:off x="2334642" y="4164106"/>
              <a:ext cx="40145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0" name="Straight Connector 59"/>
            <p:cNvCxnSpPr/>
            <p:nvPr/>
          </p:nvCxnSpPr>
          <p:spPr>
            <a:xfrm>
              <a:off x="2897557" y="4164106"/>
              <a:ext cx="40145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1" name="Group 60"/>
          <p:cNvGrpSpPr/>
          <p:nvPr/>
        </p:nvGrpSpPr>
        <p:grpSpPr>
          <a:xfrm>
            <a:off x="1309652" y="5715000"/>
            <a:ext cx="2090198" cy="0"/>
            <a:chOff x="1208814" y="4164106"/>
            <a:chExt cx="2090198" cy="0"/>
          </a:xfrm>
        </p:grpSpPr>
        <p:cxnSp>
          <p:nvCxnSpPr>
            <p:cNvPr id="62" name="Straight Connector 61"/>
            <p:cNvCxnSpPr/>
            <p:nvPr/>
          </p:nvCxnSpPr>
          <p:spPr>
            <a:xfrm>
              <a:off x="1208814" y="4164106"/>
              <a:ext cx="40145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3" name="Straight Connector 62"/>
            <p:cNvCxnSpPr/>
            <p:nvPr/>
          </p:nvCxnSpPr>
          <p:spPr>
            <a:xfrm>
              <a:off x="1771728" y="4164106"/>
              <a:ext cx="40145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4" name="Straight Connector 63"/>
            <p:cNvCxnSpPr/>
            <p:nvPr/>
          </p:nvCxnSpPr>
          <p:spPr>
            <a:xfrm>
              <a:off x="2334642" y="4164106"/>
              <a:ext cx="40145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5" name="Straight Connector 64"/>
            <p:cNvCxnSpPr/>
            <p:nvPr/>
          </p:nvCxnSpPr>
          <p:spPr>
            <a:xfrm>
              <a:off x="2897557" y="4164106"/>
              <a:ext cx="40145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6" name="Group 65"/>
          <p:cNvGrpSpPr/>
          <p:nvPr/>
        </p:nvGrpSpPr>
        <p:grpSpPr>
          <a:xfrm>
            <a:off x="1262602" y="7404490"/>
            <a:ext cx="2090198" cy="0"/>
            <a:chOff x="1208814" y="4164106"/>
            <a:chExt cx="2090198" cy="0"/>
          </a:xfrm>
        </p:grpSpPr>
        <p:cxnSp>
          <p:nvCxnSpPr>
            <p:cNvPr id="67" name="Straight Connector 66"/>
            <p:cNvCxnSpPr/>
            <p:nvPr/>
          </p:nvCxnSpPr>
          <p:spPr>
            <a:xfrm>
              <a:off x="1208814" y="4164106"/>
              <a:ext cx="40145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8" name="Straight Connector 67"/>
            <p:cNvCxnSpPr/>
            <p:nvPr/>
          </p:nvCxnSpPr>
          <p:spPr>
            <a:xfrm>
              <a:off x="1771728" y="4164106"/>
              <a:ext cx="40145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9" name="Straight Connector 68"/>
            <p:cNvCxnSpPr/>
            <p:nvPr/>
          </p:nvCxnSpPr>
          <p:spPr>
            <a:xfrm>
              <a:off x="2334642" y="4164106"/>
              <a:ext cx="40145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0" name="Straight Connector 69"/>
            <p:cNvCxnSpPr/>
            <p:nvPr/>
          </p:nvCxnSpPr>
          <p:spPr>
            <a:xfrm>
              <a:off x="2897557" y="4164106"/>
              <a:ext cx="40145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1" name="Group 70"/>
          <p:cNvGrpSpPr/>
          <p:nvPr/>
        </p:nvGrpSpPr>
        <p:grpSpPr>
          <a:xfrm>
            <a:off x="4430634" y="7337255"/>
            <a:ext cx="2090198" cy="0"/>
            <a:chOff x="1208814" y="4164106"/>
            <a:chExt cx="2090198" cy="0"/>
          </a:xfrm>
        </p:grpSpPr>
        <p:cxnSp>
          <p:nvCxnSpPr>
            <p:cNvPr id="72" name="Straight Connector 71"/>
            <p:cNvCxnSpPr/>
            <p:nvPr/>
          </p:nvCxnSpPr>
          <p:spPr>
            <a:xfrm>
              <a:off x="1208814" y="4164106"/>
              <a:ext cx="40145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3" name="Straight Connector 72"/>
            <p:cNvCxnSpPr/>
            <p:nvPr/>
          </p:nvCxnSpPr>
          <p:spPr>
            <a:xfrm>
              <a:off x="1771728" y="4164106"/>
              <a:ext cx="40145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4" name="Straight Connector 73"/>
            <p:cNvCxnSpPr/>
            <p:nvPr/>
          </p:nvCxnSpPr>
          <p:spPr>
            <a:xfrm>
              <a:off x="2334642" y="4164106"/>
              <a:ext cx="40145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5" name="Straight Connector 74"/>
            <p:cNvCxnSpPr/>
            <p:nvPr/>
          </p:nvCxnSpPr>
          <p:spPr>
            <a:xfrm>
              <a:off x="2897557" y="4164106"/>
              <a:ext cx="40145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76" name="TextBox 22"/>
          <p:cNvSpPr txBox="1"/>
          <p:nvPr/>
        </p:nvSpPr>
        <p:spPr>
          <a:xfrm rot="16200000">
            <a:off x="-504158" y="4882009"/>
            <a:ext cx="15901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/>
              <a:t>Relative expression</a:t>
            </a:r>
          </a:p>
        </p:txBody>
      </p:sp>
      <p:sp>
        <p:nvSpPr>
          <p:cNvPr id="88" name="TextBox 22"/>
          <p:cNvSpPr txBox="1"/>
          <p:nvPr/>
        </p:nvSpPr>
        <p:spPr>
          <a:xfrm>
            <a:off x="3962400" y="7356984"/>
            <a:ext cx="5013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/>
              <a:t>Ws-2</a:t>
            </a:r>
          </a:p>
        </p:txBody>
      </p:sp>
      <p:sp>
        <p:nvSpPr>
          <p:cNvPr id="89" name="TextBox 28"/>
          <p:cNvSpPr txBox="1"/>
          <p:nvPr/>
        </p:nvSpPr>
        <p:spPr>
          <a:xfrm>
            <a:off x="4329964" y="7349746"/>
            <a:ext cx="68018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200" dirty="0"/>
              <a:t>CBF1ox </a:t>
            </a:r>
          </a:p>
          <a:p>
            <a:pPr algn="ctr"/>
            <a:r>
              <a:rPr lang="en-US" sz="1200" dirty="0"/>
              <a:t>(IT)</a:t>
            </a:r>
          </a:p>
        </p:txBody>
      </p:sp>
      <p:sp>
        <p:nvSpPr>
          <p:cNvPr id="90" name="TextBox 23"/>
          <p:cNvSpPr txBox="1"/>
          <p:nvPr/>
        </p:nvSpPr>
        <p:spPr>
          <a:xfrm>
            <a:off x="4857489" y="7356096"/>
            <a:ext cx="64492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200" dirty="0"/>
              <a:t>CBF3ox</a:t>
            </a:r>
          </a:p>
          <a:p>
            <a:pPr algn="ctr"/>
            <a:r>
              <a:rPr lang="en-US" sz="1200" dirty="0"/>
              <a:t>(IT)</a:t>
            </a:r>
          </a:p>
        </p:txBody>
      </p:sp>
      <p:sp>
        <p:nvSpPr>
          <p:cNvPr id="91" name="TextBox 37"/>
          <p:cNvSpPr txBox="1"/>
          <p:nvPr/>
        </p:nvSpPr>
        <p:spPr>
          <a:xfrm>
            <a:off x="6025400" y="7358270"/>
            <a:ext cx="83260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200" dirty="0"/>
              <a:t>cbf3ox</a:t>
            </a:r>
          </a:p>
          <a:p>
            <a:pPr algn="ctr"/>
            <a:r>
              <a:rPr lang="en-US" sz="1200" dirty="0"/>
              <a:t>(it:</a:t>
            </a:r>
            <a:r>
              <a:rPr lang="en-US" sz="1200" i="1" dirty="0"/>
              <a:t>cbf123</a:t>
            </a:r>
            <a:r>
              <a:rPr lang="en-US" sz="1200" dirty="0"/>
              <a:t>)</a:t>
            </a:r>
          </a:p>
        </p:txBody>
      </p:sp>
      <p:sp>
        <p:nvSpPr>
          <p:cNvPr id="92" name="TextBox 27"/>
          <p:cNvSpPr txBox="1"/>
          <p:nvPr/>
        </p:nvSpPr>
        <p:spPr>
          <a:xfrm>
            <a:off x="5365514" y="7359181"/>
            <a:ext cx="83260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200" dirty="0"/>
              <a:t>cbf1ox</a:t>
            </a:r>
          </a:p>
          <a:p>
            <a:pPr algn="ctr"/>
            <a:r>
              <a:rPr lang="en-US" sz="1200" dirty="0"/>
              <a:t>(it:</a:t>
            </a:r>
            <a:r>
              <a:rPr lang="en-US" sz="1200" i="1" dirty="0"/>
              <a:t>cbf123</a:t>
            </a:r>
            <a:r>
              <a:rPr lang="en-US" sz="1200" dirty="0"/>
              <a:t>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B967903E-9C53-8448-8157-93726DB5077A}"/>
              </a:ext>
            </a:extLst>
          </p:cNvPr>
          <p:cNvSpPr txBox="1"/>
          <p:nvPr/>
        </p:nvSpPr>
        <p:spPr>
          <a:xfrm>
            <a:off x="455869" y="350566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A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E0767AC-A0D7-3E46-8223-A90D540FDECF}"/>
              </a:ext>
            </a:extLst>
          </p:cNvPr>
          <p:cNvSpPr txBox="1"/>
          <p:nvPr/>
        </p:nvSpPr>
        <p:spPr>
          <a:xfrm>
            <a:off x="444788" y="2397169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B)</a:t>
            </a:r>
          </a:p>
        </p:txBody>
      </p:sp>
    </p:spTree>
    <p:extLst>
      <p:ext uri="{BB962C8B-B14F-4D97-AF65-F5344CB8AC3E}">
        <p14:creationId xmlns:p14="http://schemas.microsoft.com/office/powerpoint/2010/main" val="15805922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1625</TotalTime>
  <Words>204</Words>
  <Application>Microsoft Macintosh PowerPoint</Application>
  <PresentationFormat>On-screen Show (4:3)</PresentationFormat>
  <Paragraphs>3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rk, Sunchung</dc:creator>
  <cp:lastModifiedBy>Thomashow, Michael</cp:lastModifiedBy>
  <cp:revision>230</cp:revision>
  <cp:lastPrinted>2017-03-13T20:53:07Z</cp:lastPrinted>
  <dcterms:created xsi:type="dcterms:W3CDTF">2006-08-16T00:00:00Z</dcterms:created>
  <dcterms:modified xsi:type="dcterms:W3CDTF">2018-11-09T14:24:36Z</dcterms:modified>
</cp:coreProperties>
</file>